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2" r:id="rId2"/>
    <p:sldId id="264" r:id="rId3"/>
    <p:sldId id="263" r:id="rId4"/>
    <p:sldId id="261" r:id="rId5"/>
    <p:sldId id="260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77" d="100"/>
          <a:sy n="77" d="100"/>
        </p:scale>
        <p:origin x="30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EA0E-169D-4F23-BC95-0DADC5E1C8EA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198C-8931-400F-B88A-3EA0594523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87729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EA0E-169D-4F23-BC95-0DADC5E1C8EA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198C-8931-400F-B88A-3EA0594523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38085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EA0E-169D-4F23-BC95-0DADC5E1C8EA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198C-8931-400F-B88A-3EA0594523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7403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EA0E-169D-4F23-BC95-0DADC5E1C8EA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198C-8931-400F-B88A-3EA0594523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3982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EA0E-169D-4F23-BC95-0DADC5E1C8EA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198C-8931-400F-B88A-3EA0594523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69378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EA0E-169D-4F23-BC95-0DADC5E1C8EA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198C-8931-400F-B88A-3EA0594523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61020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EA0E-169D-4F23-BC95-0DADC5E1C8EA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198C-8931-400F-B88A-3EA0594523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0724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EA0E-169D-4F23-BC95-0DADC5E1C8EA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198C-8931-400F-B88A-3EA0594523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7282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EA0E-169D-4F23-BC95-0DADC5E1C8EA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198C-8931-400F-B88A-3EA0594523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47053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EA0E-169D-4F23-BC95-0DADC5E1C8EA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198C-8931-400F-B88A-3EA0594523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9633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6CEA0E-169D-4F23-BC95-0DADC5E1C8EA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198C-8931-400F-B88A-3EA0594523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97271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6CEA0E-169D-4F23-BC95-0DADC5E1C8EA}" type="datetimeFigureOut">
              <a:rPr lang="en-GB" smtClean="0"/>
              <a:t>04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31198C-8931-400F-B88A-3EA0594523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6105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sv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sv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7030FAC-AFF2-A26E-2014-3368654F447B}"/>
              </a:ext>
            </a:extLst>
          </p:cNvPr>
          <p:cNvSpPr txBox="1"/>
          <p:nvPr/>
        </p:nvSpPr>
        <p:spPr>
          <a:xfrm>
            <a:off x="2362611" y="877548"/>
            <a:ext cx="30294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Additional Figure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013CA43-F3AC-657F-DCDC-5387FAD43652}"/>
              </a:ext>
            </a:extLst>
          </p:cNvPr>
          <p:cNvSpPr txBox="1"/>
          <p:nvPr/>
        </p:nvSpPr>
        <p:spPr>
          <a:xfrm>
            <a:off x="139263" y="3028108"/>
            <a:ext cx="6579473" cy="46396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olymorphic pseudogenes in the human genome - A comprehensive assessment</a:t>
            </a:r>
            <a:endParaRPr lang="en-GB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GB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pt-PT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ónica Lopes-Marques </a:t>
            </a:r>
            <a:r>
              <a:rPr lang="pt-PT" sz="105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*</a:t>
            </a:r>
            <a:r>
              <a:rPr lang="pt-PT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M. João Peixoto</a:t>
            </a:r>
            <a:r>
              <a:rPr lang="pt-PT" sz="105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pt-PT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David N. Cooper</a:t>
            </a:r>
            <a:r>
              <a:rPr lang="pt-PT" sz="105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pt-PT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</a:t>
            </a:r>
            <a:r>
              <a:rPr lang="pt-PT" sz="105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pt-PT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. João Prata</a:t>
            </a:r>
            <a:r>
              <a:rPr lang="pt-PT" sz="105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,4</a:t>
            </a:r>
            <a:r>
              <a:rPr lang="pt-PT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Luísa Azevedo </a:t>
            </a:r>
            <a:r>
              <a:rPr lang="pt-PT" sz="105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,6,+</a:t>
            </a:r>
            <a:r>
              <a:rPr lang="pt-PT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L. Filipe C. Castro</a:t>
            </a:r>
            <a:r>
              <a:rPr lang="pt-PT" sz="105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,4,+</a:t>
            </a:r>
            <a:endParaRPr lang="en-GB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pt-PT" sz="105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GB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GB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-</a:t>
            </a:r>
            <a:r>
              <a:rPr lang="en-GB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IIMAR-Interdisciplinary Centre of Marine and Environmental Research, University of Porto, Porto, Portugal</a:t>
            </a:r>
          </a:p>
          <a:p>
            <a:pPr>
              <a:spcAft>
                <a:spcPts val="800"/>
              </a:spcAft>
            </a:pPr>
            <a:r>
              <a:rPr lang="en-GB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-</a:t>
            </a:r>
            <a:r>
              <a:rPr lang="en-GB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stitute of Medical Genetics; School of Medicine, Cardiff University, Cardiff, UK</a:t>
            </a:r>
          </a:p>
          <a:p>
            <a:pPr>
              <a:spcAft>
                <a:spcPts val="800"/>
              </a:spcAft>
            </a:pPr>
            <a:r>
              <a:rPr lang="pt-PT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- </a:t>
            </a:r>
            <a:r>
              <a:rPr lang="pt-PT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3S‐Instituto de Investigação e Inovação em Saúde, </a:t>
            </a:r>
            <a:r>
              <a:rPr lang="pt-PT" sz="9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iversity</a:t>
            </a:r>
            <a:r>
              <a:rPr lang="pt-PT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pt-PT" sz="9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</a:t>
            </a:r>
            <a:r>
              <a:rPr lang="pt-PT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orto, Porto, Portugal</a:t>
            </a:r>
            <a:endParaRPr lang="en-GB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GB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-</a:t>
            </a:r>
            <a:r>
              <a:rPr lang="en-GB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CUP- Faculty of Sciences, Biology Department, University of Porto, Porto, Portugal</a:t>
            </a:r>
            <a:r>
              <a:rPr lang="en-GB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GB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GB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-</a:t>
            </a:r>
            <a:r>
              <a:rPr lang="en-GB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UMIB-Unit for Multidisciplinary Research in Biomedicine, ICBAS - School of Medicine and Biomedical Sciences, University of Porto, Porto, Portugal</a:t>
            </a:r>
          </a:p>
          <a:p>
            <a:pPr>
              <a:spcAft>
                <a:spcPts val="800"/>
              </a:spcAft>
            </a:pPr>
            <a:r>
              <a:rPr lang="en-GB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6- </a:t>
            </a:r>
            <a:r>
              <a:rPr lang="en-GB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TR - Laboratory for Integrative and Translational Research in Population Health, Porto, Portugal</a:t>
            </a:r>
          </a:p>
          <a:p>
            <a:pPr>
              <a:spcAft>
                <a:spcPts val="800"/>
              </a:spcAft>
            </a:pPr>
            <a:r>
              <a:rPr lang="en-GB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GB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GB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GB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GB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* Corresponding author</a:t>
            </a:r>
            <a:endParaRPr lang="en-GB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GB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+ joint last authors</a:t>
            </a:r>
            <a:endParaRPr lang="en-GB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17774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DDCDFFE-1497-DC62-547C-E707CE6F288A}"/>
              </a:ext>
            </a:extLst>
          </p:cNvPr>
          <p:cNvSpPr txBox="1"/>
          <p:nvPr/>
        </p:nvSpPr>
        <p:spPr>
          <a:xfrm>
            <a:off x="367089" y="6487535"/>
            <a:ext cx="61238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/>
              <a:t>Additional Figure 1: </a:t>
            </a:r>
            <a:r>
              <a:rPr lang="en-US" sz="1000" dirty="0"/>
              <a:t>Workflow</a:t>
            </a:r>
            <a:r>
              <a:rPr lang="en-US" sz="1000" b="1" dirty="0"/>
              <a:t> </a:t>
            </a:r>
            <a:r>
              <a:rPr lang="en-GB" sz="1000" dirty="0"/>
              <a:t>rationale for the identification and validation of polymorphic pseudogenes</a:t>
            </a:r>
          </a:p>
        </p:txBody>
      </p:sp>
      <p:pic>
        <p:nvPicPr>
          <p:cNvPr id="3" name="Picture 2" descr="A diagram of a flowchart&#10;&#10;Description automatically generated">
            <a:extLst>
              <a:ext uri="{FF2B5EF4-FFF2-40B4-BE49-F238E27FC236}">
                <a16:creationId xmlns:a16="http://schemas.microsoft.com/office/drawing/2014/main" id="{A09E2AD3-6D06-C23B-38F3-32D4E23CD7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89870"/>
            <a:ext cx="6858000" cy="5143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89408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BADC443-B5F9-FFE6-B669-30697D72F1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54276" y="449721"/>
            <a:ext cx="2638948" cy="131371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B0FBA69-ED7B-3919-0610-9392EB46B69F}"/>
              </a:ext>
            </a:extLst>
          </p:cNvPr>
          <p:cNvSpPr txBox="1"/>
          <p:nvPr/>
        </p:nvSpPr>
        <p:spPr>
          <a:xfrm>
            <a:off x="3949858" y="4640551"/>
            <a:ext cx="19233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In the NOR group, 50% of the genes carry a </a:t>
            </a:r>
            <a:r>
              <a:rPr lang="en-US" sz="600" dirty="0" err="1"/>
              <a:t>LoF</a:t>
            </a:r>
            <a:r>
              <a:rPr lang="en-US" sz="600" dirty="0"/>
              <a:t> allele with a frequency between 10%-50%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71CCBD6-90D1-0750-48C3-4CBA16F02CA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63875" y="2439173"/>
            <a:ext cx="4359367" cy="218348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F059881-E77A-D8CE-DA36-D725625A6856}"/>
              </a:ext>
            </a:extLst>
          </p:cNvPr>
          <p:cNvSpPr txBox="1"/>
          <p:nvPr/>
        </p:nvSpPr>
        <p:spPr>
          <a:xfrm>
            <a:off x="1751244" y="4640277"/>
            <a:ext cx="19233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/>
              <a:t>In the OR group, 50% of the genes carry a </a:t>
            </a:r>
            <a:r>
              <a:rPr lang="en-US" sz="600" dirty="0" err="1"/>
              <a:t>LoF</a:t>
            </a:r>
            <a:r>
              <a:rPr lang="en-US" sz="600" dirty="0"/>
              <a:t> allele with a frequency between 20%-60%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21FC2DF1-FFA5-17EA-210A-4105138DA9BB}"/>
              </a:ext>
            </a:extLst>
          </p:cNvPr>
          <p:cNvGrpSpPr/>
          <p:nvPr/>
        </p:nvGrpSpPr>
        <p:grpSpPr>
          <a:xfrm>
            <a:off x="1753694" y="5852750"/>
            <a:ext cx="3517735" cy="3377553"/>
            <a:chOff x="1857851" y="1642832"/>
            <a:chExt cx="3517735" cy="3377553"/>
          </a:xfrm>
        </p:grpSpPr>
        <p:pic>
          <p:nvPicPr>
            <p:cNvPr id="12" name="Picture 11" descr="A graph of different colored bars&#10;&#10;Description automatically generated">
              <a:extLst>
                <a:ext uri="{FF2B5EF4-FFF2-40B4-BE49-F238E27FC236}">
                  <a16:creationId xmlns:a16="http://schemas.microsoft.com/office/drawing/2014/main" id="{BA2F0C9B-723C-2114-8791-E24292150C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11" r="1759"/>
            <a:stretch/>
          </p:blipFill>
          <p:spPr>
            <a:xfrm rot="5400000">
              <a:off x="1855555" y="1645128"/>
              <a:ext cx="3091280" cy="3086688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60078324-82C1-A1CC-1D6D-4888C5C02743}"/>
                </a:ext>
              </a:extLst>
            </p:cNvPr>
            <p:cNvSpPr txBox="1"/>
            <p:nvPr/>
          </p:nvSpPr>
          <p:spPr>
            <a:xfrm>
              <a:off x="4716714" y="4696992"/>
              <a:ext cx="48135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i="1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100%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F1F83E6-4477-CB2D-3E1E-FF0D0DB49A16}"/>
                </a:ext>
              </a:extLst>
            </p:cNvPr>
            <p:cNvSpPr txBox="1"/>
            <p:nvPr/>
          </p:nvSpPr>
          <p:spPr>
            <a:xfrm>
              <a:off x="4127992" y="4696992"/>
              <a:ext cx="371534" cy="1889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i="1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80%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CB7C6EC-7EE7-3E7B-C1D3-69B39B8117C5}"/>
                </a:ext>
              </a:extLst>
            </p:cNvPr>
            <p:cNvSpPr txBox="1"/>
            <p:nvPr/>
          </p:nvSpPr>
          <p:spPr>
            <a:xfrm>
              <a:off x="3597834" y="4696992"/>
              <a:ext cx="371534" cy="1889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i="1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60%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CB332CE-8892-22B1-80F6-3EDA77566BD8}"/>
                </a:ext>
              </a:extLst>
            </p:cNvPr>
            <p:cNvSpPr txBox="1"/>
            <p:nvPr/>
          </p:nvSpPr>
          <p:spPr>
            <a:xfrm>
              <a:off x="3006373" y="4696992"/>
              <a:ext cx="371534" cy="1889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i="1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40%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954ABBA-21C1-9DCA-A24F-48441B5A2AD9}"/>
                </a:ext>
              </a:extLst>
            </p:cNvPr>
            <p:cNvSpPr txBox="1"/>
            <p:nvPr/>
          </p:nvSpPr>
          <p:spPr>
            <a:xfrm>
              <a:off x="2445564" y="4696992"/>
              <a:ext cx="371534" cy="1889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i="1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20%</a:t>
              </a:r>
            </a:p>
          </p:txBody>
        </p: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C68E9994-AB90-1901-1396-E614F6459555}"/>
                </a:ext>
              </a:extLst>
            </p:cNvPr>
            <p:cNvCxnSpPr>
              <a:cxnSpLocks/>
            </p:cNvCxnSpPr>
            <p:nvPr/>
          </p:nvCxnSpPr>
          <p:spPr>
            <a:xfrm>
              <a:off x="2225992" y="4919742"/>
              <a:ext cx="2593292" cy="0"/>
            </a:xfrm>
            <a:prstGeom prst="straightConnector1">
              <a:avLst/>
            </a:prstGeom>
            <a:ln w="6350"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815FAB5-0840-B282-016C-3EF76181AFDD}"/>
                </a:ext>
              </a:extLst>
            </p:cNvPr>
            <p:cNvSpPr txBox="1"/>
            <p:nvPr/>
          </p:nvSpPr>
          <p:spPr>
            <a:xfrm>
              <a:off x="4819284" y="4831426"/>
              <a:ext cx="556302" cy="1889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600" i="1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Ψ</a:t>
              </a:r>
              <a:r>
                <a:rPr lang="pt-PT" sz="600" i="1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 </a:t>
              </a:r>
              <a:r>
                <a:rPr lang="en-US" sz="600" i="1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Fixation </a:t>
              </a:r>
            </a:p>
          </p:txBody>
        </p: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5615E2F7-0C8B-2EDF-C79D-60400470539A}"/>
                </a:ext>
              </a:extLst>
            </p:cNvPr>
            <p:cNvCxnSpPr>
              <a:cxnSpLocks/>
            </p:cNvCxnSpPr>
            <p:nvPr/>
          </p:nvCxnSpPr>
          <p:spPr>
            <a:xfrm>
              <a:off x="5015712" y="1658150"/>
              <a:ext cx="0" cy="3075962"/>
            </a:xfrm>
            <a:prstGeom prst="straightConnector1">
              <a:avLst/>
            </a:prstGeom>
            <a:ln w="6350">
              <a:solidFill>
                <a:schemeClr val="tx1">
                  <a:lumMod val="65000"/>
                  <a:lumOff val="35000"/>
                </a:schemeClr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55A8A489-64E1-6511-7346-316C522B7DFA}"/>
                </a:ext>
              </a:extLst>
            </p:cNvPr>
            <p:cNvSpPr txBox="1"/>
            <p:nvPr/>
          </p:nvSpPr>
          <p:spPr>
            <a:xfrm rot="5400000">
              <a:off x="4408012" y="2367857"/>
              <a:ext cx="1404359" cy="1889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i="1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Average Global Freq. of </a:t>
              </a:r>
              <a:r>
                <a:rPr lang="en-US" sz="600" i="1" dirty="0" err="1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LoF</a:t>
              </a:r>
              <a:r>
                <a:rPr lang="en-US" sz="600" i="1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 allele</a:t>
              </a:r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EC6CB45C-3622-24B4-6A96-DDD7A7A8762C}"/>
              </a:ext>
            </a:extLst>
          </p:cNvPr>
          <p:cNvSpPr txBox="1"/>
          <p:nvPr/>
        </p:nvSpPr>
        <p:spPr>
          <a:xfrm>
            <a:off x="294032" y="9256274"/>
            <a:ext cx="629112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Additional Figure 2. A)</a:t>
            </a:r>
            <a:r>
              <a:rPr lang="en-US" sz="1000" dirty="0"/>
              <a:t> Pairwise intersection table of shared polymorphic pseudogenes in the 1KGP populations. </a:t>
            </a:r>
            <a:r>
              <a:rPr lang="en-US" sz="1000" b="1" dirty="0"/>
              <a:t>B)</a:t>
            </a:r>
            <a:r>
              <a:rPr lang="en-US" sz="1000" dirty="0"/>
              <a:t> Box plot graph showing the distribution of the global average of the </a:t>
            </a:r>
            <a:r>
              <a:rPr lang="en-US" sz="1000" dirty="0" err="1"/>
              <a:t>LoF</a:t>
            </a:r>
            <a:r>
              <a:rPr lang="en-US" sz="1000" dirty="0"/>
              <a:t> alleles. </a:t>
            </a:r>
            <a:r>
              <a:rPr lang="en-US" sz="1000" b="1" dirty="0"/>
              <a:t>C)</a:t>
            </a:r>
            <a:r>
              <a:rPr lang="en-US" sz="1000" dirty="0"/>
              <a:t> 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stribution of </a:t>
            </a:r>
            <a:r>
              <a:rPr lang="en-US" sz="1000" dirty="0" err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oF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llele average global frequencies in OR  polymorphic pseudogenes in the 1KGP.</a:t>
            </a:r>
            <a:r>
              <a:rPr lang="en-US" sz="10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000" dirty="0"/>
              <a:t>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27022F2-0007-5CC7-340C-7192FF740334}"/>
              </a:ext>
            </a:extLst>
          </p:cNvPr>
          <p:cNvSpPr txBox="1"/>
          <p:nvPr/>
        </p:nvSpPr>
        <p:spPr>
          <a:xfrm>
            <a:off x="994351" y="115786"/>
            <a:ext cx="339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400" b="1" dirty="0"/>
              <a:t>A</a:t>
            </a:r>
            <a:endParaRPr lang="en-GB" sz="14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1B6B80D-8EF4-C638-1D23-39C874CA0A39}"/>
              </a:ext>
            </a:extLst>
          </p:cNvPr>
          <p:cNvSpPr txBox="1"/>
          <p:nvPr/>
        </p:nvSpPr>
        <p:spPr>
          <a:xfrm>
            <a:off x="1030885" y="2466091"/>
            <a:ext cx="339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400" b="1" dirty="0"/>
              <a:t>B</a:t>
            </a:r>
            <a:endParaRPr lang="en-GB" sz="14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C43B614-9F93-6649-E5EF-AB1F2F5DD05E}"/>
              </a:ext>
            </a:extLst>
          </p:cNvPr>
          <p:cNvSpPr txBox="1"/>
          <p:nvPr/>
        </p:nvSpPr>
        <p:spPr>
          <a:xfrm>
            <a:off x="978845" y="5500974"/>
            <a:ext cx="339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400" b="1" dirty="0"/>
              <a:t>C</a:t>
            </a:r>
            <a:endParaRPr lang="en-GB" sz="1400" b="1" dirty="0"/>
          </a:p>
        </p:txBody>
      </p:sp>
    </p:spTree>
    <p:extLst>
      <p:ext uri="{BB962C8B-B14F-4D97-AF65-F5344CB8AC3E}">
        <p14:creationId xmlns:p14="http://schemas.microsoft.com/office/powerpoint/2010/main" val="251311981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/>
      <p:bldP spid="7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C946D3A-F0A1-60E2-7347-FE25CE3E4D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7833" y="1084209"/>
            <a:ext cx="4822334" cy="359551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E6F7214-137B-86D3-6594-32025D17996D}"/>
              </a:ext>
            </a:extLst>
          </p:cNvPr>
          <p:cNvSpPr txBox="1"/>
          <p:nvPr/>
        </p:nvSpPr>
        <p:spPr>
          <a:xfrm>
            <a:off x="763548" y="2745331"/>
            <a:ext cx="339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400" b="1" dirty="0"/>
              <a:t>B</a:t>
            </a:r>
            <a:endParaRPr lang="en-GB" sz="14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A17ACC0-A173-BFEF-1ABF-228660A6F5B0}"/>
              </a:ext>
            </a:extLst>
          </p:cNvPr>
          <p:cNvSpPr txBox="1"/>
          <p:nvPr/>
        </p:nvSpPr>
        <p:spPr>
          <a:xfrm>
            <a:off x="848309" y="1013727"/>
            <a:ext cx="339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400" b="1" dirty="0"/>
              <a:t>A</a:t>
            </a:r>
            <a:endParaRPr lang="en-GB" sz="14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9B5837F-74D5-84FC-C065-3A3286B3DD05}"/>
              </a:ext>
            </a:extLst>
          </p:cNvPr>
          <p:cNvSpPr txBox="1"/>
          <p:nvPr/>
        </p:nvSpPr>
        <p:spPr>
          <a:xfrm>
            <a:off x="309384" y="5420520"/>
            <a:ext cx="643596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/>
              <a:t>Additional Figure 3</a:t>
            </a:r>
            <a:r>
              <a:rPr lang="en-US" sz="1000" dirty="0"/>
              <a:t>: </a:t>
            </a:r>
            <a:r>
              <a:rPr lang="pt-PT" sz="1000" b="1" dirty="0"/>
              <a:t>A </a:t>
            </a:r>
            <a:r>
              <a:rPr lang="pt-PT" sz="1000" dirty="0" err="1"/>
              <a:t>Histogram</a:t>
            </a:r>
            <a:r>
              <a:rPr lang="en-GB" sz="1000" dirty="0"/>
              <a:t> of the cumulative TPM values per tissue of polymorphic pseudogenes in the </a:t>
            </a:r>
            <a:r>
              <a:rPr lang="en-GB" sz="1000" dirty="0" err="1"/>
              <a:t>GTEx</a:t>
            </a:r>
            <a:r>
              <a:rPr lang="en-GB" sz="1000" dirty="0"/>
              <a:t> transcriptome, B- Histogram of the number of pseudogenes expressed in each tissue in the </a:t>
            </a:r>
            <a:r>
              <a:rPr lang="en-GB" sz="1000" dirty="0" err="1"/>
              <a:t>GTEx</a:t>
            </a:r>
            <a:r>
              <a:rPr lang="en-GB" sz="1000" dirty="0"/>
              <a:t> transcriptome. </a:t>
            </a:r>
            <a:endParaRPr lang="en-US" sz="10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07412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E3BE18D-4CFE-D94F-2A07-5F41AFEDE8A6}"/>
              </a:ext>
            </a:extLst>
          </p:cNvPr>
          <p:cNvSpPr txBox="1"/>
          <p:nvPr/>
        </p:nvSpPr>
        <p:spPr>
          <a:xfrm>
            <a:off x="344553" y="8466175"/>
            <a:ext cx="643596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/>
              <a:t>Additional figure 4</a:t>
            </a:r>
            <a:r>
              <a:rPr lang="en-US" sz="1000" dirty="0"/>
              <a:t>: </a:t>
            </a:r>
            <a:r>
              <a:rPr lang="en-US" sz="1000" b="1" dirty="0"/>
              <a:t>A</a:t>
            </a:r>
            <a:r>
              <a:rPr lang="en-US" sz="1000" dirty="0"/>
              <a:t>-Clustered heatmap of the expression of the Non-OR polymorphic pseudogenes detected in the </a:t>
            </a:r>
            <a:r>
              <a:rPr lang="en-US" sz="1000" dirty="0" err="1">
                <a:ea typeface="Calibri" panose="020F0502020204030204" pitchFamily="34" charset="0"/>
                <a:cs typeface="Arial" panose="020B0604020202020204" pitchFamily="34" charset="0"/>
              </a:rPr>
              <a:t>GTEx</a:t>
            </a:r>
            <a:r>
              <a:rPr lang="en-US" sz="1000" dirty="0">
                <a:ea typeface="Calibri" panose="020F0502020204030204" pitchFamily="34" charset="0"/>
                <a:cs typeface="Arial" panose="020B0604020202020204" pitchFamily="34" charset="0"/>
              </a:rPr>
              <a:t> project. </a:t>
            </a:r>
            <a:r>
              <a:rPr lang="en-US" sz="1000" b="1" dirty="0"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000" dirty="0"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sz="1000" dirty="0"/>
              <a:t>Clustered heatmap of the expression of the OR polymorphic pseudogenes detected in the </a:t>
            </a:r>
            <a:r>
              <a:rPr lang="en-US" sz="1000" dirty="0" err="1">
                <a:ea typeface="Calibri" panose="020F0502020204030204" pitchFamily="34" charset="0"/>
                <a:cs typeface="Arial" panose="020B0604020202020204" pitchFamily="34" charset="0"/>
              </a:rPr>
              <a:t>GTEx</a:t>
            </a:r>
            <a:r>
              <a:rPr lang="en-US" sz="1000" dirty="0">
                <a:ea typeface="Calibri" panose="020F0502020204030204" pitchFamily="34" charset="0"/>
                <a:cs typeface="Arial" panose="020B0604020202020204" pitchFamily="34" charset="0"/>
              </a:rPr>
              <a:t> project. </a:t>
            </a:r>
          </a:p>
        </p:txBody>
      </p:sp>
      <p:pic>
        <p:nvPicPr>
          <p:cNvPr id="8" name="Graphic 7">
            <a:extLst>
              <a:ext uri="{FF2B5EF4-FFF2-40B4-BE49-F238E27FC236}">
                <a16:creationId xmlns:a16="http://schemas.microsoft.com/office/drawing/2014/main" id="{91B27F65-CDB1-A66B-0393-8C19959B5CE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 r="6887"/>
          <a:stretch/>
        </p:blipFill>
        <p:spPr>
          <a:xfrm rot="16200000">
            <a:off x="-2107894" y="2395918"/>
            <a:ext cx="8245323" cy="3735536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57F6CF6C-BE23-91D8-39AD-80CAEEF935AC}"/>
              </a:ext>
            </a:extLst>
          </p:cNvPr>
          <p:cNvGrpSpPr/>
          <p:nvPr/>
        </p:nvGrpSpPr>
        <p:grpSpPr>
          <a:xfrm>
            <a:off x="3736410" y="6553330"/>
            <a:ext cx="381243" cy="1036190"/>
            <a:chOff x="3691016" y="6475957"/>
            <a:chExt cx="381243" cy="1036190"/>
          </a:xfrm>
        </p:grpSpPr>
        <p:pic>
          <p:nvPicPr>
            <p:cNvPr id="2" name="Graphic 1">
              <a:extLst>
                <a:ext uri="{FF2B5EF4-FFF2-40B4-BE49-F238E27FC236}">
                  <a16:creationId xmlns:a16="http://schemas.microsoft.com/office/drawing/2014/main" id="{A4C9DBF4-01A8-0688-849C-1DC4A12C7D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rcRect l="92054" t="9958" r="4531" b="68011"/>
            <a:stretch/>
          </p:blipFill>
          <p:spPr>
            <a:xfrm>
              <a:off x="3694015" y="6689184"/>
              <a:ext cx="302457" cy="822963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3D1A88C9-9AEB-BF9D-5D48-6342E67C7B11}"/>
                </a:ext>
              </a:extLst>
            </p:cNvPr>
            <p:cNvSpPr txBox="1"/>
            <p:nvPr/>
          </p:nvSpPr>
          <p:spPr>
            <a:xfrm>
              <a:off x="3691016" y="6475957"/>
              <a:ext cx="3812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PT" sz="6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Log</a:t>
              </a:r>
              <a:r>
                <a:rPr lang="pt-PT" sz="600" b="1" baseline="-25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2</a:t>
              </a:r>
              <a:r>
                <a:rPr lang="pt-PT" sz="6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TPM</a:t>
              </a:r>
              <a:endParaRPr lang="en-GB" sz="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9F4551EB-CC22-4428-CD02-62DC77150F4F}"/>
              </a:ext>
            </a:extLst>
          </p:cNvPr>
          <p:cNvGrpSpPr/>
          <p:nvPr/>
        </p:nvGrpSpPr>
        <p:grpSpPr>
          <a:xfrm>
            <a:off x="4446640" y="611944"/>
            <a:ext cx="1879143" cy="2370810"/>
            <a:chOff x="4446640" y="611944"/>
            <a:chExt cx="1879143" cy="2370810"/>
          </a:xfrm>
        </p:grpSpPr>
        <p:pic>
          <p:nvPicPr>
            <p:cNvPr id="7" name="Graphic 6">
              <a:extLst>
                <a:ext uri="{FF2B5EF4-FFF2-40B4-BE49-F238E27FC236}">
                  <a16:creationId xmlns:a16="http://schemas.microsoft.com/office/drawing/2014/main" id="{1D6E42B2-68B5-73D4-B4C6-D669B80FBF6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rcRect l="2867" t="26177" r="9055" b="30471"/>
            <a:stretch/>
          </p:blipFill>
          <p:spPr>
            <a:xfrm rot="16200000">
              <a:off x="3983231" y="1075353"/>
              <a:ext cx="2370810" cy="1443991"/>
            </a:xfrm>
            <a:prstGeom prst="rect">
              <a:avLst/>
            </a:prstGeom>
          </p:spPr>
        </p:pic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78FBC538-B3CC-A806-0146-16334350FB3D}"/>
                </a:ext>
              </a:extLst>
            </p:cNvPr>
            <p:cNvGrpSpPr/>
            <p:nvPr/>
          </p:nvGrpSpPr>
          <p:grpSpPr>
            <a:xfrm>
              <a:off x="5944540" y="1658847"/>
              <a:ext cx="381243" cy="1323907"/>
              <a:chOff x="5867168" y="1658848"/>
              <a:chExt cx="381243" cy="1323907"/>
            </a:xfrm>
          </p:grpSpPr>
          <p:pic>
            <p:nvPicPr>
              <p:cNvPr id="6" name="Graphic 5">
                <a:extLst>
                  <a:ext uri="{FF2B5EF4-FFF2-40B4-BE49-F238E27FC236}">
                    <a16:creationId xmlns:a16="http://schemas.microsoft.com/office/drawing/2014/main" id="{EDC21B3B-2067-5596-B46E-E7FE97BC5D6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5"/>
                  </a:ext>
                </a:extLst>
              </a:blip>
              <a:srcRect l="89399" t="36135" r="982" b="30471"/>
              <a:stretch/>
            </p:blipFill>
            <p:spPr>
              <a:xfrm>
                <a:off x="5955305" y="1870451"/>
                <a:ext cx="258906" cy="1112304"/>
              </a:xfrm>
              <a:prstGeom prst="rect">
                <a:avLst/>
              </a:prstGeom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4C99A299-A25E-291C-A01B-BE273ACE8ACA}"/>
                  </a:ext>
                </a:extLst>
              </p:cNvPr>
              <p:cNvSpPr txBox="1"/>
              <p:nvPr/>
            </p:nvSpPr>
            <p:spPr>
              <a:xfrm>
                <a:off x="5867168" y="1658848"/>
                <a:ext cx="38124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PT" sz="6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Log</a:t>
                </a:r>
                <a:r>
                  <a:rPr lang="pt-PT" sz="600" b="1" baseline="-25000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2</a:t>
                </a:r>
                <a:r>
                  <a:rPr lang="pt-PT" sz="6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TPM</a:t>
                </a:r>
                <a:endParaRPr lang="en-GB" sz="6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68168FBA-038C-C312-CC17-E06595D7BE8A}"/>
              </a:ext>
            </a:extLst>
          </p:cNvPr>
          <p:cNvSpPr txBox="1"/>
          <p:nvPr/>
        </p:nvSpPr>
        <p:spPr>
          <a:xfrm>
            <a:off x="4072259" y="458054"/>
            <a:ext cx="339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400" b="1" dirty="0"/>
              <a:t>B</a:t>
            </a:r>
            <a:endParaRPr lang="en-GB" sz="14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FE421D7-5D73-C954-D8CF-3627E0AB52AE}"/>
              </a:ext>
            </a:extLst>
          </p:cNvPr>
          <p:cNvSpPr txBox="1"/>
          <p:nvPr/>
        </p:nvSpPr>
        <p:spPr>
          <a:xfrm>
            <a:off x="146999" y="458053"/>
            <a:ext cx="3390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400" b="1" dirty="0"/>
              <a:t>A</a:t>
            </a:r>
            <a:endParaRPr lang="en-GB" sz="1400" b="1" dirty="0"/>
          </a:p>
        </p:txBody>
      </p:sp>
    </p:spTree>
    <p:extLst>
      <p:ext uri="{BB962C8B-B14F-4D97-AF65-F5344CB8AC3E}">
        <p14:creationId xmlns:p14="http://schemas.microsoft.com/office/powerpoint/2010/main" val="40243101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519</TotalTime>
  <Words>372</Words>
  <Application>Microsoft Office PowerPoint</Application>
  <PresentationFormat>A4 Paper (210x297 mm)</PresentationFormat>
  <Paragraphs>3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2013 - 2022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ónica Marques</dc:creator>
  <cp:lastModifiedBy>Mónica Marques</cp:lastModifiedBy>
  <cp:revision>24</cp:revision>
  <dcterms:created xsi:type="dcterms:W3CDTF">2023-12-05T10:46:54Z</dcterms:created>
  <dcterms:modified xsi:type="dcterms:W3CDTF">2024-06-04T15:12:59Z</dcterms:modified>
</cp:coreProperties>
</file>